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0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646CD-306A-4C99-8C1C-E98CFED63CAD}" type="datetimeFigureOut">
              <a:rPr lang="zh-CN" altLang="en-US" smtClean="0"/>
              <a:pPr/>
              <a:t>2020/12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CC2FA-A3B5-4CCE-A39B-1AF7BEF517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jpeg"/><Relationship Id="rId3" Type="http://schemas.openxmlformats.org/officeDocument/2006/relationships/image" Target="../media/image27.jpeg"/><Relationship Id="rId7" Type="http://schemas.openxmlformats.org/officeDocument/2006/relationships/image" Target="../media/image31.jpeg"/><Relationship Id="rId12" Type="http://schemas.openxmlformats.org/officeDocument/2006/relationships/image" Target="../media/image9.png"/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jpeg"/><Relationship Id="rId11" Type="http://schemas.openxmlformats.org/officeDocument/2006/relationships/image" Target="../media/image35.jpeg"/><Relationship Id="rId5" Type="http://schemas.openxmlformats.org/officeDocument/2006/relationships/image" Target="../media/image29.jpeg"/><Relationship Id="rId10" Type="http://schemas.openxmlformats.org/officeDocument/2006/relationships/image" Target="../media/image34.jpeg"/><Relationship Id="rId4" Type="http://schemas.openxmlformats.org/officeDocument/2006/relationships/image" Target="../media/image28.jpeg"/><Relationship Id="rId9" Type="http://schemas.openxmlformats.org/officeDocument/2006/relationships/image" Target="../media/image33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jpeg"/><Relationship Id="rId3" Type="http://schemas.openxmlformats.org/officeDocument/2006/relationships/image" Target="../media/image37.jpeg"/><Relationship Id="rId7" Type="http://schemas.openxmlformats.org/officeDocument/2006/relationships/image" Target="../media/image41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jpeg"/><Relationship Id="rId11" Type="http://schemas.openxmlformats.org/officeDocument/2006/relationships/image" Target="../media/image9.png"/><Relationship Id="rId5" Type="http://schemas.openxmlformats.org/officeDocument/2006/relationships/image" Target="../media/image39.jpeg"/><Relationship Id="rId10" Type="http://schemas.openxmlformats.org/officeDocument/2006/relationships/image" Target="../media/image43.jpeg"/><Relationship Id="rId4" Type="http://schemas.openxmlformats.org/officeDocument/2006/relationships/image" Target="../media/image38.jpeg"/><Relationship Id="rId9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论文\试验数据\2016-2020\CFs aging\human\第一批\2018.4.27 第一批\2TGFB 20180427_200757_Ch\2TGFB 20180427_200757_Ch+Marker.jpg"/>
          <p:cNvPicPr>
            <a:picLocks noChangeAspect="1" noChangeArrowheads="1"/>
          </p:cNvPicPr>
          <p:nvPr/>
        </p:nvPicPr>
        <p:blipFill>
          <a:blip r:embed="rId2" cstate="print"/>
          <a:srcRect l="7370" t="43263" r="7881" b="41998"/>
          <a:stretch>
            <a:fillRect/>
          </a:stretch>
        </p:blipFill>
        <p:spPr bwMode="auto">
          <a:xfrm>
            <a:off x="1331640" y="1314392"/>
            <a:ext cx="3312368" cy="576064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539552" y="1412776"/>
            <a:ext cx="13681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GF-β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 descr="E:\论文\试验数据\2016-2020\CFs aging\human\第一批\2018.5.20 第一批\2-gap 20180521_004124_Ch\2-gap 20180521_004124_Ch+Marker.jpg"/>
          <p:cNvPicPr>
            <a:picLocks noChangeAspect="1" noChangeArrowheads="1"/>
          </p:cNvPicPr>
          <p:nvPr/>
        </p:nvPicPr>
        <p:blipFill>
          <a:blip r:embed="rId3" cstate="print"/>
          <a:srcRect l="7370" t="33163" r="7881" b="29990"/>
          <a:stretch>
            <a:fillRect/>
          </a:stretch>
        </p:blipFill>
        <p:spPr bwMode="auto">
          <a:xfrm>
            <a:off x="1331640" y="1916832"/>
            <a:ext cx="3312368" cy="720080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467544" y="206084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 descr="E:\论文\试验数据\2016-2020\CFs aging\human\第二批\2018.05.28gxy人（第二批组织）\4TGFB_3 20180528_103334_Ch\4TGFB_3 20180528_103334_Ch+Marker.jpg"/>
          <p:cNvPicPr>
            <a:picLocks noChangeAspect="1" noChangeArrowheads="1"/>
          </p:cNvPicPr>
          <p:nvPr/>
        </p:nvPicPr>
        <p:blipFill>
          <a:blip r:embed="rId4" cstate="print"/>
          <a:srcRect l="14739" t="58326" r="2354" b="21407"/>
          <a:stretch>
            <a:fillRect/>
          </a:stretch>
        </p:blipFill>
        <p:spPr bwMode="auto">
          <a:xfrm>
            <a:off x="1289784" y="3149760"/>
            <a:ext cx="3312368" cy="792088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548776" y="3390488"/>
            <a:ext cx="13681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GF-β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 descr="E:\论文\试验数据\2016-2020\CFs aging\human\第二批\2018.05.28gxy人（第二批组织）\3GAPDH_3 20180529_205824_Ch\3GAPDH_3 20180529_205824_Ch+Marker.jpg"/>
          <p:cNvPicPr>
            <a:picLocks noChangeAspect="1" noChangeArrowheads="1"/>
          </p:cNvPicPr>
          <p:nvPr/>
        </p:nvPicPr>
        <p:blipFill>
          <a:blip r:embed="rId5" cstate="print"/>
          <a:srcRect l="2055" t="36627" r="13196" b="44949"/>
          <a:stretch>
            <a:fillRect/>
          </a:stretch>
        </p:blipFill>
        <p:spPr bwMode="auto">
          <a:xfrm>
            <a:off x="1289784" y="3978688"/>
            <a:ext cx="3312368" cy="720080"/>
          </a:xfrm>
          <a:prstGeom prst="rect">
            <a:avLst/>
          </a:prstGeom>
          <a:noFill/>
        </p:spPr>
      </p:pic>
      <p:pic>
        <p:nvPicPr>
          <p:cNvPr id="1031" name="Picture 7" descr="E:\论文\试验数据\2016-2020\CFs aging\human\第三批\2018.05.24gxy人（第三批组织）\2TGFB_2 20180524_103212_Ch\2TGFB_2 20180524_103212_Ch+Marker.jpg"/>
          <p:cNvPicPr>
            <a:picLocks noChangeAspect="1" noChangeArrowheads="1"/>
          </p:cNvPicPr>
          <p:nvPr/>
        </p:nvPicPr>
        <p:blipFill>
          <a:blip r:embed="rId6" cstate="print"/>
          <a:srcRect l="14739" t="40532" b="46571"/>
          <a:stretch>
            <a:fillRect/>
          </a:stretch>
        </p:blipFill>
        <p:spPr bwMode="auto">
          <a:xfrm>
            <a:off x="5610264" y="1349560"/>
            <a:ext cx="3332361" cy="504056"/>
          </a:xfrm>
          <a:prstGeom prst="rect">
            <a:avLst/>
          </a:prstGeom>
          <a:noFill/>
        </p:spPr>
      </p:pic>
      <p:pic>
        <p:nvPicPr>
          <p:cNvPr id="1032" name="Picture 8" descr="E:\论文\试验数据\2016-2020\CFs aging\human\第三批\2018.05.24gxy人（第三批组织）\2GAPDH_2 20180525_185017_Ch\2GAPDH_2 20180525_185017_Ch+Marker.jpg"/>
          <p:cNvPicPr>
            <a:picLocks noChangeAspect="1" noChangeArrowheads="1"/>
          </p:cNvPicPr>
          <p:nvPr/>
        </p:nvPicPr>
        <p:blipFill>
          <a:blip r:embed="rId7" cstate="print"/>
          <a:srcRect l="9676" t="41919" r="5574" b="41499"/>
          <a:stretch>
            <a:fillRect/>
          </a:stretch>
        </p:blipFill>
        <p:spPr bwMode="auto">
          <a:xfrm>
            <a:off x="5610264" y="1925624"/>
            <a:ext cx="3312368" cy="648072"/>
          </a:xfrm>
          <a:prstGeom prst="rect">
            <a:avLst/>
          </a:prstGeom>
          <a:noFill/>
        </p:spPr>
      </p:pic>
      <p:pic>
        <p:nvPicPr>
          <p:cNvPr id="1033" name="Picture 9" descr="E:\论文\试验数据\2016-2020\CFs aging\human\第四批\2018.06.30人组织蛋白（新第四批）\2TGF 20180630_154109_Ch\2TGF 20180630_154109_Ch+Marker.jpg"/>
          <p:cNvPicPr>
            <a:picLocks noChangeAspect="1" noChangeArrowheads="1"/>
          </p:cNvPicPr>
          <p:nvPr/>
        </p:nvPicPr>
        <p:blipFill>
          <a:blip r:embed="rId8" cstate="print"/>
          <a:srcRect l="5527" t="33162" r="6039" b="53941"/>
          <a:stretch>
            <a:fillRect/>
          </a:stretch>
        </p:blipFill>
        <p:spPr bwMode="auto">
          <a:xfrm>
            <a:off x="5627848" y="3308016"/>
            <a:ext cx="3240360" cy="504056"/>
          </a:xfrm>
          <a:prstGeom prst="rect">
            <a:avLst/>
          </a:prstGeom>
          <a:noFill/>
        </p:spPr>
      </p:pic>
      <p:pic>
        <p:nvPicPr>
          <p:cNvPr id="1034" name="Picture 10" descr="E:\论文\试验数据\2016-2020\CFs aging\human\第四批\2018.06.30人组织蛋白（新第四批）\2GAPDH 20180630_155245_Ch\2GAPDH 20180630_155245_Ch+Marker.jpg"/>
          <p:cNvPicPr>
            <a:picLocks noChangeAspect="1" noChangeArrowheads="1"/>
          </p:cNvPicPr>
          <p:nvPr/>
        </p:nvPicPr>
        <p:blipFill>
          <a:blip r:embed="rId9" cstate="print"/>
          <a:srcRect l="9212" t="37695" r="4196" b="45359"/>
          <a:stretch>
            <a:fillRect/>
          </a:stretch>
        </p:blipFill>
        <p:spPr bwMode="auto">
          <a:xfrm>
            <a:off x="5627848" y="3853928"/>
            <a:ext cx="3240360" cy="662312"/>
          </a:xfrm>
          <a:prstGeom prst="rect">
            <a:avLst/>
          </a:prstGeom>
          <a:noFill/>
        </p:spPr>
      </p:pic>
      <p:sp>
        <p:nvSpPr>
          <p:cNvPr id="13" name="TextBox 12"/>
          <p:cNvSpPr txBox="1"/>
          <p:nvPr/>
        </p:nvSpPr>
        <p:spPr>
          <a:xfrm>
            <a:off x="4865480" y="1430360"/>
            <a:ext cx="13681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GF-β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56632" y="2078432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48288" y="414908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90184" y="3437792"/>
            <a:ext cx="13681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GF-β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781336" y="3997944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1721832" y="127588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2945968" y="1277552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269168" y="1008776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096112" y="101589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6089616" y="1321512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7313752" y="1323184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689704" y="1052736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402352" y="106152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1705920" y="3121712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2930056" y="3123384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306008" y="2861728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097784" y="286172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6233632" y="326572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7396224" y="326740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698496" y="2996952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618376" y="29881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0" y="0"/>
            <a:ext cx="2123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tri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tissue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6" name="Picture 3"/>
          <p:cNvPicPr>
            <a:picLocks noChangeAspect="1" noChangeArrowheads="1"/>
          </p:cNvPicPr>
          <p:nvPr/>
        </p:nvPicPr>
        <p:blipFill>
          <a:blip r:embed="rId10" cstate="print"/>
          <a:srcRect t="5401"/>
          <a:stretch>
            <a:fillRect/>
          </a:stretch>
        </p:blipFill>
        <p:spPr bwMode="auto">
          <a:xfrm>
            <a:off x="0" y="4437112"/>
            <a:ext cx="514500" cy="2420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TextBox 36"/>
          <p:cNvSpPr txBox="1"/>
          <p:nvPr/>
        </p:nvSpPr>
        <p:spPr>
          <a:xfrm>
            <a:off x="4139952" y="43651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451640" y="160954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388424" y="3501008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03112" y="354664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211960" y="159363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4139952" y="1709600"/>
            <a:ext cx="1440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8460432" y="213285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8388424" y="39611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论文\试验数据\2016-2020\CFs aging\human\第一批\2018.4.27 第一批\1PAI 20180427_201541_Ch\1PAI 20180427_201541_Ch+Marker.jpg"/>
          <p:cNvPicPr>
            <a:picLocks noChangeAspect="1" noChangeArrowheads="1"/>
          </p:cNvPicPr>
          <p:nvPr/>
        </p:nvPicPr>
        <p:blipFill>
          <a:blip r:embed="rId2" cstate="print"/>
          <a:srcRect l="14739" t="51587" b="33674"/>
          <a:stretch>
            <a:fillRect/>
          </a:stretch>
        </p:blipFill>
        <p:spPr bwMode="auto">
          <a:xfrm>
            <a:off x="864096" y="1196752"/>
            <a:ext cx="3332361" cy="576064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16024" y="1340768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 descr="E:\论文\试验数据\2016-2020\CFs aging\human\第二批\2018.4.10.11人心房组织标本第二批\2PAI-1 20180411_115955_Ch\2PAI-1 20180411_115955_Ch+Marker.jpg"/>
          <p:cNvPicPr>
            <a:picLocks noChangeAspect="1" noChangeArrowheads="1"/>
          </p:cNvPicPr>
          <p:nvPr/>
        </p:nvPicPr>
        <p:blipFill>
          <a:blip r:embed="rId3" cstate="print"/>
          <a:srcRect l="4009" t="44475" r="5784" b="35258"/>
          <a:stretch>
            <a:fillRect/>
          </a:stretch>
        </p:blipFill>
        <p:spPr bwMode="auto">
          <a:xfrm>
            <a:off x="892144" y="3429000"/>
            <a:ext cx="3312368" cy="792088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172064" y="3645024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2" name="Picture 4" descr="E:\论文\试验数据\2016-2020\CFs aging\human\第二批\2018.4.10.11人心房组织标本第二批\4GAPDH 20180411_121332_Ch\4GAPDH 20180411_121332_Ch+Marker.jpg"/>
          <p:cNvPicPr>
            <a:picLocks noChangeAspect="1" noChangeArrowheads="1"/>
          </p:cNvPicPr>
          <p:nvPr/>
        </p:nvPicPr>
        <p:blipFill>
          <a:blip r:embed="rId4" cstate="print"/>
          <a:srcRect l="7331" t="42374" r="9685" b="42886"/>
          <a:stretch>
            <a:fillRect/>
          </a:stretch>
        </p:blipFill>
        <p:spPr bwMode="auto">
          <a:xfrm>
            <a:off x="892144" y="4293096"/>
            <a:ext cx="3312368" cy="576064"/>
          </a:xfrm>
          <a:prstGeom prst="rect">
            <a:avLst/>
          </a:prstGeom>
          <a:noFill/>
        </p:spPr>
      </p:pic>
      <p:pic>
        <p:nvPicPr>
          <p:cNvPr id="2054" name="Picture 6" descr="E:\论文\试验数据\2016-2020\CFs aging\human\第三批\2018.05.24gxy人（第三批组织）\1PAI_1 20180524_103622_Ch\1PAI_1 20180524_103622_Ch+Marker.jpg"/>
          <p:cNvPicPr>
            <a:picLocks noChangeAspect="1" noChangeArrowheads="1"/>
          </p:cNvPicPr>
          <p:nvPr/>
        </p:nvPicPr>
        <p:blipFill>
          <a:blip r:embed="rId5" cstate="print"/>
          <a:srcRect l="5455" t="33322" r="7953" b="50096"/>
          <a:stretch>
            <a:fillRect/>
          </a:stretch>
        </p:blipFill>
        <p:spPr bwMode="auto">
          <a:xfrm>
            <a:off x="5220072" y="1230680"/>
            <a:ext cx="3456384" cy="648072"/>
          </a:xfrm>
          <a:prstGeom prst="rect">
            <a:avLst/>
          </a:prstGeom>
          <a:noFill/>
        </p:spPr>
      </p:pic>
      <p:pic>
        <p:nvPicPr>
          <p:cNvPr id="2055" name="Picture 7" descr="E:\论文\试验数据\2016-2020\CFs aging\human\第三批\2018.05.24gxy人（第三批组织）\1GAPDH_2 20180525_184547_Ch\1GAPDH_2 20180525_184547_Ch+Marker.jpg"/>
          <p:cNvPicPr>
            <a:picLocks noChangeAspect="1" noChangeArrowheads="1"/>
          </p:cNvPicPr>
          <p:nvPr/>
        </p:nvPicPr>
        <p:blipFill>
          <a:blip r:embed="rId6" cstate="print"/>
          <a:srcRect l="8610" t="41817" r="6640" b="41601"/>
          <a:stretch>
            <a:fillRect/>
          </a:stretch>
        </p:blipFill>
        <p:spPr bwMode="auto">
          <a:xfrm>
            <a:off x="5220072" y="1915592"/>
            <a:ext cx="3456384" cy="648072"/>
          </a:xfrm>
          <a:prstGeom prst="rect">
            <a:avLst/>
          </a:prstGeom>
          <a:noFill/>
        </p:spPr>
      </p:pic>
      <p:pic>
        <p:nvPicPr>
          <p:cNvPr id="2056" name="Picture 8" descr="E:\论文\试验数据\2016-2020\CFs aging\human\第四批\2018.06.30人组织蛋白（新第四批）\1PAI1 20180630_144521_Ch\1PAI1 20180630_144521_Ch+Marker.jpg"/>
          <p:cNvPicPr>
            <a:picLocks noChangeAspect="1" noChangeArrowheads="1"/>
          </p:cNvPicPr>
          <p:nvPr/>
        </p:nvPicPr>
        <p:blipFill>
          <a:blip r:embed="rId7" cstate="print"/>
          <a:srcRect t="46715" r="12221" b="40388"/>
          <a:stretch>
            <a:fillRect/>
          </a:stretch>
        </p:blipFill>
        <p:spPr bwMode="auto">
          <a:xfrm>
            <a:off x="5292080" y="3621184"/>
            <a:ext cx="3430785" cy="504056"/>
          </a:xfrm>
          <a:prstGeom prst="rect">
            <a:avLst/>
          </a:prstGeom>
          <a:noFill/>
        </p:spPr>
      </p:pic>
      <p:pic>
        <p:nvPicPr>
          <p:cNvPr id="2057" name="Picture 9" descr="E:\论文\试验数据\2016-2020\CFs aging\human\第四批\2018.06.30人组织蛋白（新第四批）\1GAPDH 20180630_155027_Ch\1GAPDH 20180630_155027_Ch+Marker.jpg"/>
          <p:cNvPicPr>
            <a:picLocks noChangeAspect="1" noChangeArrowheads="1"/>
          </p:cNvPicPr>
          <p:nvPr/>
        </p:nvPicPr>
        <p:blipFill>
          <a:blip r:embed="rId8" cstate="print"/>
          <a:srcRect l="1842" t="43513" r="15251" b="41747"/>
          <a:stretch>
            <a:fillRect/>
          </a:stretch>
        </p:blipFill>
        <p:spPr bwMode="auto">
          <a:xfrm>
            <a:off x="5292080" y="4170872"/>
            <a:ext cx="3456384" cy="576064"/>
          </a:xfrm>
          <a:prstGeom prst="rect">
            <a:avLst/>
          </a:prstGeom>
          <a:noFill/>
        </p:spPr>
      </p:pic>
      <p:pic>
        <p:nvPicPr>
          <p:cNvPr id="3074" name="Picture 2" descr="E:\论文\试验数据\2016-2020\CFs aging\human\第一批\2018.4.27 第一批\2018.04.26\1GAPDH 20180427_093824_Ch\1GAPDH 20180427_093824_Ch+Marker.jpg"/>
          <p:cNvPicPr>
            <a:picLocks noChangeAspect="1" noChangeArrowheads="1"/>
          </p:cNvPicPr>
          <p:nvPr/>
        </p:nvPicPr>
        <p:blipFill>
          <a:blip r:embed="rId9" cstate="print"/>
          <a:srcRect l="15806" t="45448" b="36128"/>
          <a:stretch>
            <a:fillRect/>
          </a:stretch>
        </p:blipFill>
        <p:spPr bwMode="auto">
          <a:xfrm>
            <a:off x="864096" y="1819772"/>
            <a:ext cx="3312368" cy="720080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0" y="198884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376" y="441240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587912" y="1393952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64768" y="2077192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644008" y="3738824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427984" y="431488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1443832" y="1168704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2667968" y="1170376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987824" y="908720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835696" y="90872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5708216" y="119508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6949936" y="1196752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306632" y="935096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108872" y="93509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1522960" y="339048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2703136" y="339216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017544" y="313050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869192" y="312338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5915448" y="358892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7122000" y="359060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7434736" y="332182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268800" y="33113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0" y="0"/>
            <a:ext cx="2123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tri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tissue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779912" y="447892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851920" y="220486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816752" y="12495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116304" y="135835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760656" y="378904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179520" y="36379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172400" y="214332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334000" y="419304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论文\试验数据\2016-2020\CFs aging\human\第一批\2018-2-8第一批\1P53_1 20180208_141722_Ch\1P53_1 20180208_141722_Ch+Marker.jpg"/>
          <p:cNvPicPr>
            <a:picLocks noChangeAspect="1" noChangeArrowheads="1"/>
          </p:cNvPicPr>
          <p:nvPr/>
        </p:nvPicPr>
        <p:blipFill>
          <a:blip r:embed="rId2" cstate="print"/>
          <a:srcRect l="7725" t="39434" r="1998" b="42141"/>
          <a:stretch>
            <a:fillRect/>
          </a:stretch>
        </p:blipFill>
        <p:spPr bwMode="auto">
          <a:xfrm>
            <a:off x="1020576" y="979056"/>
            <a:ext cx="3456384" cy="648072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444512" y="1123072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5" name="Picture 3" descr="E:\论文\试验数据\2016-2020\CFs aging\human\第一批\2018-2-8第一批\2GAPDH 20180208_140453_Ch\2GAPDH 20180208_140453_Ch+Marker.jpg"/>
          <p:cNvPicPr>
            <a:picLocks noChangeAspect="1" noChangeArrowheads="1"/>
          </p:cNvPicPr>
          <p:nvPr/>
        </p:nvPicPr>
        <p:blipFill>
          <a:blip r:embed="rId3" cstate="print"/>
          <a:srcRect l="7369" t="32445" r="2354" b="54659"/>
          <a:stretch>
            <a:fillRect/>
          </a:stretch>
        </p:blipFill>
        <p:spPr bwMode="auto">
          <a:xfrm>
            <a:off x="1020576" y="1699136"/>
            <a:ext cx="3456384" cy="504056"/>
          </a:xfrm>
          <a:prstGeom prst="rect">
            <a:avLst/>
          </a:prstGeom>
          <a:noFill/>
        </p:spPr>
      </p:pic>
      <p:pic>
        <p:nvPicPr>
          <p:cNvPr id="3076" name="Picture 4" descr="E:\论文\试验数据\2016-2020\CFs aging\human\第二批\2018.05.13-15人第二批组织\2P53_2 20180514_194622_Ch\2P53_2 20180514_194622_Ch+Marker.jpg"/>
          <p:cNvPicPr>
            <a:picLocks noChangeAspect="1" noChangeArrowheads="1"/>
          </p:cNvPicPr>
          <p:nvPr/>
        </p:nvPicPr>
        <p:blipFill>
          <a:blip r:embed="rId4" cstate="print"/>
          <a:srcRect l="11054" t="44217" r="2354" b="35516"/>
          <a:stretch>
            <a:fillRect/>
          </a:stretch>
        </p:blipFill>
        <p:spPr bwMode="auto">
          <a:xfrm>
            <a:off x="941448" y="3645024"/>
            <a:ext cx="3456384" cy="648072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365384" y="378904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7" name="Picture 5" descr="E:\论文\试验数据\2016-2020\CFs aging\human\第二批\2018.05.13-15人第二批组织\1GAPDH1 20180515_095250_Ch\1GAPDH1 20180515_095250_Ch+Marker.jpg"/>
          <p:cNvPicPr>
            <a:picLocks noChangeAspect="1" noChangeArrowheads="1"/>
          </p:cNvPicPr>
          <p:nvPr/>
        </p:nvPicPr>
        <p:blipFill>
          <a:blip r:embed="rId5" cstate="print"/>
          <a:srcRect l="3305" t="37091" r="13787" b="40800"/>
          <a:stretch>
            <a:fillRect/>
          </a:stretch>
        </p:blipFill>
        <p:spPr bwMode="auto">
          <a:xfrm>
            <a:off x="941448" y="4365104"/>
            <a:ext cx="3456384" cy="720080"/>
          </a:xfrm>
          <a:prstGeom prst="rect">
            <a:avLst/>
          </a:prstGeom>
          <a:noFill/>
        </p:spPr>
      </p:pic>
      <p:pic>
        <p:nvPicPr>
          <p:cNvPr id="3078" name="Picture 6" descr="E:\论文\试验数据\2016-2020\CFs aging\human\第三批\2018.05.10gxy第三批人组织蛋白\用1P53 20180511_123935_Ch\1 20180511_123935_Ch+Marker.jpg"/>
          <p:cNvPicPr>
            <a:picLocks noChangeAspect="1" noChangeArrowheads="1"/>
          </p:cNvPicPr>
          <p:nvPr/>
        </p:nvPicPr>
        <p:blipFill>
          <a:blip r:embed="rId6" cstate="print"/>
          <a:srcRect l="5527" t="47901" r="7881" b="39201"/>
          <a:stretch>
            <a:fillRect/>
          </a:stretch>
        </p:blipFill>
        <p:spPr bwMode="auto">
          <a:xfrm>
            <a:off x="5364088" y="1052736"/>
            <a:ext cx="3384376" cy="504056"/>
          </a:xfrm>
          <a:prstGeom prst="rect">
            <a:avLst/>
          </a:prstGeom>
          <a:noFill/>
        </p:spPr>
      </p:pic>
      <p:pic>
        <p:nvPicPr>
          <p:cNvPr id="3079" name="Picture 7" descr="E:\论文\试验数据\2016-2020\CFs aging\human\第三批\2018.05.10gxy第三批人组织蛋白\用1GAPDH 20180511_125330_Ch\1GAPDH 20180511_125330_Ch+Marker.jpg"/>
          <p:cNvPicPr>
            <a:picLocks noChangeAspect="1" noChangeArrowheads="1"/>
          </p:cNvPicPr>
          <p:nvPr/>
        </p:nvPicPr>
        <p:blipFill>
          <a:blip r:embed="rId7" cstate="print"/>
          <a:srcRect l="5785" t="45282" r="7622" b="41821"/>
          <a:stretch>
            <a:fillRect/>
          </a:stretch>
        </p:blipFill>
        <p:spPr bwMode="auto">
          <a:xfrm>
            <a:off x="5364088" y="1628800"/>
            <a:ext cx="3384376" cy="504056"/>
          </a:xfrm>
          <a:prstGeom prst="rect">
            <a:avLst/>
          </a:prstGeom>
          <a:noFill/>
        </p:spPr>
      </p:pic>
      <p:pic>
        <p:nvPicPr>
          <p:cNvPr id="3080" name="Picture 8" descr="E:\论文\试验数据\2016-2020\CFs aging\human\第四批\2018.06.28人组织蛋白（新第四批）\1P53_2 20180628_120532_Ch\1P53_2 20180628_120532_Ch+Marker.jpg"/>
          <p:cNvPicPr>
            <a:picLocks noChangeAspect="1" noChangeArrowheads="1"/>
          </p:cNvPicPr>
          <p:nvPr/>
        </p:nvPicPr>
        <p:blipFill>
          <a:blip r:embed="rId8" cstate="print"/>
          <a:srcRect l="4396" t="42001" r="10855" b="43259"/>
          <a:stretch>
            <a:fillRect/>
          </a:stretch>
        </p:blipFill>
        <p:spPr bwMode="auto">
          <a:xfrm>
            <a:off x="5292080" y="3717032"/>
            <a:ext cx="3312368" cy="576064"/>
          </a:xfrm>
          <a:prstGeom prst="rect">
            <a:avLst/>
          </a:prstGeom>
          <a:noFill/>
        </p:spPr>
      </p:pic>
      <p:pic>
        <p:nvPicPr>
          <p:cNvPr id="3081" name="Picture 9" descr="E:\论文\试验数据\2016-2020\CFs aging\human\第四批\2018.06.28人组织蛋白（新第四批）\1GAPDH 20180629_102737_Ch\1GAPDH 20180629_102737_Ch+Marker.jpg"/>
          <p:cNvPicPr>
            <a:picLocks noChangeAspect="1" noChangeArrowheads="1"/>
          </p:cNvPicPr>
          <p:nvPr/>
        </p:nvPicPr>
        <p:blipFill>
          <a:blip r:embed="rId9" cstate="print"/>
          <a:srcRect l="9447" t="42601" r="5803" b="35291"/>
          <a:stretch>
            <a:fillRect/>
          </a:stretch>
        </p:blipFill>
        <p:spPr bwMode="auto">
          <a:xfrm>
            <a:off x="5292080" y="4365104"/>
            <a:ext cx="3312368" cy="720080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84472" y="1771144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7352" y="458112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95200" y="1124744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36832" y="170080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812728" y="3861048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54360" y="4630536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1566920" y="94388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2791056" y="93676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147752" y="673440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941200" y="67511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5843440" y="102468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7067576" y="1026360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380312" y="76470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260008" y="76470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8" name="直接连接符 27"/>
          <p:cNvCxnSpPr/>
          <p:nvPr/>
        </p:nvCxnSpPr>
        <p:spPr>
          <a:xfrm>
            <a:off x="1450952" y="3616976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2675088" y="3618648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2987824" y="3348200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842816" y="3348200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5789016" y="3680192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7013152" y="3681864"/>
            <a:ext cx="108012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7380312" y="340974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R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180880" y="341141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F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0" y="0"/>
            <a:ext cx="2123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tri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tissue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23928" y="472514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923928" y="367307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923928" y="102636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244408" y="112474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100392" y="378904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316416" y="177281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923928" y="188166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论文\试验数据\2016-2020\CFs aging\GXY\HCF 过表达和敲低\HCF P11 Down p53si\2019.11.22 p11p53si(p871582 p863383)\膜4\-2-PAI1 20191129_114044_Ch\-2-PAI1 20191129_114044_Ch+Marker.jpg"/>
          <p:cNvPicPr>
            <a:picLocks noChangeAspect="1" noChangeArrowheads="1"/>
          </p:cNvPicPr>
          <p:nvPr/>
        </p:nvPicPr>
        <p:blipFill>
          <a:blip r:embed="rId2" cstate="print"/>
          <a:srcRect t="42374" r="22620" b="41044"/>
          <a:stretch>
            <a:fillRect/>
          </a:stretch>
        </p:blipFill>
        <p:spPr bwMode="auto">
          <a:xfrm>
            <a:off x="899592" y="980728"/>
            <a:ext cx="3096344" cy="576064"/>
          </a:xfrm>
          <a:prstGeom prst="rect">
            <a:avLst/>
          </a:prstGeom>
          <a:noFill/>
        </p:spPr>
      </p:pic>
      <p:pic>
        <p:nvPicPr>
          <p:cNvPr id="1027" name="Picture 3" descr="E:\论文\试验数据\2016-2020\CFs aging\GXY\HCF 过表达和敲低\HCF P11 Down p53si\2019.11.22 p11p53si(p871582 p863383)\膜4\2-G 20191127_111218_Ch\2-G 20191127_111218_Ch+Marker.jpg"/>
          <p:cNvPicPr>
            <a:picLocks noChangeAspect="1" noChangeArrowheads="1"/>
          </p:cNvPicPr>
          <p:nvPr/>
        </p:nvPicPr>
        <p:blipFill>
          <a:blip r:embed="rId3" cstate="print"/>
          <a:srcRect l="7370" t="33163" r="9723" b="50256"/>
          <a:stretch>
            <a:fillRect/>
          </a:stretch>
        </p:blipFill>
        <p:spPr bwMode="auto">
          <a:xfrm>
            <a:off x="899592" y="1593632"/>
            <a:ext cx="3096344" cy="648072"/>
          </a:xfrm>
          <a:prstGeom prst="rect">
            <a:avLst/>
          </a:prstGeom>
          <a:noFill/>
        </p:spPr>
      </p:pic>
      <p:pic>
        <p:nvPicPr>
          <p:cNvPr id="1028" name="Picture 4" descr="E:\论文\试验数据\2016-2020\CFs aging\GXY\HCF 过表达和敲低\HCF P11 Down p53si\2020.5.28 p11~p12p53si(p846949 p874863)共3个板\p846949：板1\膜2（前3孔）\4-PAI1 20200530_172902_Ch\4-PAI1 20200530_172902_Ch+Marker.jpg"/>
          <p:cNvPicPr>
            <a:picLocks noChangeAspect="1" noChangeArrowheads="1"/>
          </p:cNvPicPr>
          <p:nvPr/>
        </p:nvPicPr>
        <p:blipFill>
          <a:blip r:embed="rId4" cstate="print"/>
          <a:srcRect l="5047" t="22772" r="3019" b="56962"/>
          <a:stretch>
            <a:fillRect/>
          </a:stretch>
        </p:blipFill>
        <p:spPr bwMode="auto">
          <a:xfrm>
            <a:off x="899592" y="2564904"/>
            <a:ext cx="3528392" cy="792088"/>
          </a:xfrm>
          <a:prstGeom prst="rect">
            <a:avLst/>
          </a:prstGeom>
          <a:noFill/>
        </p:spPr>
      </p:pic>
      <p:pic>
        <p:nvPicPr>
          <p:cNvPr id="1029" name="Picture 5" descr="E:\论文\试验数据\2016-2020\CFs aging\GXY\HCF 过表达和敲低\HCF P11 Down p53si\2020.5.28 p11~p12p53si(p846949 p874863)共3个板\p846949：板1\膜2（前3孔）\4-G. 20200528_163845_Ch\4-G. 20200528_163845_Ch+Marker.jpg"/>
          <p:cNvPicPr>
            <a:picLocks noChangeAspect="1" noChangeArrowheads="1"/>
          </p:cNvPicPr>
          <p:nvPr/>
        </p:nvPicPr>
        <p:blipFill>
          <a:blip r:embed="rId5" cstate="print"/>
          <a:srcRect l="11286" t="38690" b="51198"/>
          <a:stretch>
            <a:fillRect/>
          </a:stretch>
        </p:blipFill>
        <p:spPr bwMode="auto">
          <a:xfrm>
            <a:off x="899592" y="3393832"/>
            <a:ext cx="3528392" cy="395208"/>
          </a:xfrm>
          <a:prstGeom prst="rect">
            <a:avLst/>
          </a:prstGeom>
          <a:noFill/>
        </p:spPr>
      </p:pic>
      <p:pic>
        <p:nvPicPr>
          <p:cNvPr id="1030" name="Picture 6" descr="E:\论文\试验数据\2016-2020\CFs aging\GXY\HCF 过表达和敲低\HCF P11 Down p53si\2019.11.16 p11p53si(p871582)\膜2\1-P53 20191130_115749_Ch\1-P53 20191130_115749_Ch+Marker.jpg"/>
          <p:cNvPicPr>
            <a:picLocks noChangeAspect="1" noChangeArrowheads="1"/>
          </p:cNvPicPr>
          <p:nvPr/>
        </p:nvPicPr>
        <p:blipFill>
          <a:blip r:embed="rId6" cstate="print"/>
          <a:srcRect l="36848" t="36147" r="17092" b="38059"/>
          <a:stretch>
            <a:fillRect/>
          </a:stretch>
        </p:blipFill>
        <p:spPr bwMode="auto">
          <a:xfrm>
            <a:off x="6156176" y="908720"/>
            <a:ext cx="1800200" cy="792088"/>
          </a:xfrm>
          <a:prstGeom prst="rect">
            <a:avLst/>
          </a:prstGeom>
          <a:noFill/>
        </p:spPr>
      </p:pic>
      <p:pic>
        <p:nvPicPr>
          <p:cNvPr id="1031" name="Picture 7" descr="E:\论文\试验数据\2016-2020\CFs aging\GXY\HCF 过表达和敲低\HCF P11 Down p53si\2019.11.16 p11p53si(p871582)\膜2\1-G 20191129_123822_Ch\1-G 20191129_123822_Ch+Marker.jpg"/>
          <p:cNvPicPr>
            <a:picLocks noChangeAspect="1" noChangeArrowheads="1"/>
          </p:cNvPicPr>
          <p:nvPr/>
        </p:nvPicPr>
        <p:blipFill>
          <a:blip r:embed="rId7" cstate="print"/>
          <a:srcRect l="38690" t="38690" r="17093" b="48413"/>
          <a:stretch>
            <a:fillRect/>
          </a:stretch>
        </p:blipFill>
        <p:spPr bwMode="auto">
          <a:xfrm>
            <a:off x="6156176" y="1728856"/>
            <a:ext cx="1800200" cy="504056"/>
          </a:xfrm>
          <a:prstGeom prst="rect">
            <a:avLst/>
          </a:prstGeom>
          <a:noFill/>
        </p:spPr>
      </p:pic>
      <p:pic>
        <p:nvPicPr>
          <p:cNvPr id="1032" name="Picture 8" descr="E:\论文\试验数据\2016-2020\CFs aging\GXY\HCF 过表达和敲低\HCF P11 Down p53si\2019.11.22 p11p53si(p871582 p863383)\膜2\4-P53 20191122_183717_Ch\4-P53 20191122_183717_Ch+Marker.jpg"/>
          <p:cNvPicPr>
            <a:picLocks noChangeAspect="1" noChangeArrowheads="1"/>
          </p:cNvPicPr>
          <p:nvPr/>
        </p:nvPicPr>
        <p:blipFill>
          <a:blip r:embed="rId8" cstate="print"/>
          <a:srcRect l="3685" t="36630" r="8278" b="46788"/>
          <a:stretch>
            <a:fillRect/>
          </a:stretch>
        </p:blipFill>
        <p:spPr bwMode="auto">
          <a:xfrm>
            <a:off x="5364088" y="2636912"/>
            <a:ext cx="3440881" cy="648072"/>
          </a:xfrm>
          <a:prstGeom prst="rect">
            <a:avLst/>
          </a:prstGeom>
          <a:noFill/>
        </p:spPr>
      </p:pic>
      <p:pic>
        <p:nvPicPr>
          <p:cNvPr id="1033" name="Picture 9" descr="E:\论文\试验数据\2016-2020\CFs aging\GXY\HCF 过表达和敲低\HCF P11 Down p53si\2019.11.22 p11p53si(p871582 p863383)\膜2\4-G 20191122_182306_Ch\4-G 20191122_182306_Ch+Marker.jpg"/>
          <p:cNvPicPr>
            <a:picLocks noChangeAspect="1" noChangeArrowheads="1"/>
          </p:cNvPicPr>
          <p:nvPr/>
        </p:nvPicPr>
        <p:blipFill>
          <a:blip r:embed="rId9" cstate="print"/>
          <a:srcRect l="3533" t="53130" r="9875" b="32131"/>
          <a:stretch>
            <a:fillRect/>
          </a:stretch>
        </p:blipFill>
        <p:spPr bwMode="auto">
          <a:xfrm>
            <a:off x="5364088" y="3302568"/>
            <a:ext cx="3456384" cy="576064"/>
          </a:xfrm>
          <a:prstGeom prst="rect">
            <a:avLst/>
          </a:prstGeom>
          <a:noFill/>
        </p:spPr>
      </p:pic>
      <p:pic>
        <p:nvPicPr>
          <p:cNvPr id="1034" name="Picture 10" descr="E:\论文\试验数据\2016-2020\CFs aging\GXY\HCF 过表达和敲低\HCF P11 Down p53si\2020.5.28 p11~p12p53si(p846949 p874863)共3个板\p874863：板2\膜1（后3孔）\3-GAP 20200531_145232_Ch\GAPLYY 20200531_145232_Ch+Marker.jpg"/>
          <p:cNvPicPr>
            <a:picLocks noChangeAspect="1" noChangeArrowheads="1"/>
          </p:cNvPicPr>
          <p:nvPr/>
        </p:nvPicPr>
        <p:blipFill>
          <a:blip r:embed="rId10" cstate="print"/>
          <a:srcRect l="5033" t="37242" r="4690" b="40649"/>
          <a:stretch>
            <a:fillRect/>
          </a:stretch>
        </p:blipFill>
        <p:spPr bwMode="auto">
          <a:xfrm>
            <a:off x="5364088" y="5194032"/>
            <a:ext cx="3456384" cy="864096"/>
          </a:xfrm>
          <a:prstGeom prst="rect">
            <a:avLst/>
          </a:prstGeom>
          <a:noFill/>
        </p:spPr>
      </p:pic>
      <p:pic>
        <p:nvPicPr>
          <p:cNvPr id="1035" name="Picture 11" descr="E:\论文\试验数据\2016-2020\CFs aging\GXY\HCF 过表达和敲低\HCF P11 Down p53si\2020.5.28 p11~p12p53si(p846949 p874863)共3个板\p874863：板2\膜1（后3孔）\3-p53 20200530_172718_Ch\3-p53 20200530_172718_Ch+Marker.jpg"/>
          <p:cNvPicPr>
            <a:picLocks noChangeAspect="1" noChangeArrowheads="1"/>
          </p:cNvPicPr>
          <p:nvPr/>
        </p:nvPicPr>
        <p:blipFill>
          <a:blip r:embed="rId11" cstate="print"/>
          <a:srcRect t="46958" r="13633" b="30933"/>
          <a:stretch>
            <a:fillRect/>
          </a:stretch>
        </p:blipFill>
        <p:spPr bwMode="auto">
          <a:xfrm>
            <a:off x="5372880" y="4301888"/>
            <a:ext cx="3447592" cy="864096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223472" y="118628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4752" y="1772816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51520" y="2780928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AI-1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960" y="3448256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96024" y="1124744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62360" y="178328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823192" y="2780928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98320" y="338504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07112" y="5471600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831984" y="4626760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298520" y="698144"/>
            <a:ext cx="1728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ontrol  NC  p53siRN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962808" y="780616"/>
            <a:ext cx="1728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ontrol  NC  p53siRN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222112" y="782288"/>
            <a:ext cx="1728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ontrol  NC  p53siRN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94744" y="2392840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21264" y="2392840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34136" y="2392840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724128" y="2420888"/>
            <a:ext cx="1728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ontrol  NC  p53siRN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969192" y="2429680"/>
            <a:ext cx="17281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Control  NC  p53siRNA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488848" y="4103448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449656" y="4113912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252208" y="4113912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0" y="0"/>
            <a:ext cx="320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tri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fibroblast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4" name="Picture 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25052" y="3806020"/>
            <a:ext cx="586508" cy="29741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6" name="直接箭头连接符 35"/>
          <p:cNvCxnSpPr/>
          <p:nvPr/>
        </p:nvCxnSpPr>
        <p:spPr>
          <a:xfrm>
            <a:off x="5220072" y="4653136"/>
            <a:ext cx="432048" cy="0"/>
          </a:xfrm>
          <a:prstGeom prst="straightConnector1">
            <a:avLst/>
          </a:prstGeom>
          <a:ln w="19050"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7981080" y="43651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380312" y="126876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043608" y="2780928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372568" y="117037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3311024" y="1305600"/>
            <a:ext cx="1440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5508104" y="2780928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5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论文\试验数据\2016-2020\CFs aging\GXY\HCF 过表达和敲低\HCF P11 Down p53si\2019.11.16 p11p53si(p871582)\膜1\H-COL1 20191120_220707_Ch\H-COL1 20191120_220707_Ch+Marker.jpg"/>
          <p:cNvPicPr>
            <a:picLocks noChangeAspect="1" noChangeArrowheads="1"/>
          </p:cNvPicPr>
          <p:nvPr/>
        </p:nvPicPr>
        <p:blipFill>
          <a:blip r:embed="rId2" cstate="print"/>
          <a:srcRect l="31489" t="38701" r="22451" b="41033"/>
          <a:stretch>
            <a:fillRect/>
          </a:stretch>
        </p:blipFill>
        <p:spPr bwMode="auto">
          <a:xfrm>
            <a:off x="1331640" y="719072"/>
            <a:ext cx="2160240" cy="792088"/>
          </a:xfrm>
          <a:prstGeom prst="rect">
            <a:avLst/>
          </a:prstGeom>
          <a:noFill/>
        </p:spPr>
      </p:pic>
      <p:pic>
        <p:nvPicPr>
          <p:cNvPr id="2051" name="Picture 3" descr="E:\论文\试验数据\2016-2020\CFs aging\GXY\HCF 过表达和敲低\HCF P11 Down p53si\2019.11.16 p11p53si(p871582)\膜1\H-COL3 20191120_171918_Ch\H-COL3 20191120_171918_Ch+Marker.jpg"/>
          <p:cNvPicPr>
            <a:picLocks noChangeAspect="1" noChangeArrowheads="1"/>
          </p:cNvPicPr>
          <p:nvPr/>
        </p:nvPicPr>
        <p:blipFill>
          <a:blip r:embed="rId3" cstate="print"/>
          <a:srcRect l="26384" t="38926" r="22029" b="40808"/>
          <a:stretch>
            <a:fillRect/>
          </a:stretch>
        </p:blipFill>
        <p:spPr bwMode="auto">
          <a:xfrm>
            <a:off x="1331640" y="1556792"/>
            <a:ext cx="2160240" cy="792088"/>
          </a:xfrm>
          <a:prstGeom prst="rect">
            <a:avLst/>
          </a:prstGeom>
          <a:noFill/>
        </p:spPr>
      </p:pic>
      <p:pic>
        <p:nvPicPr>
          <p:cNvPr id="2053" name="Picture 5" descr="E:\论文\试验数据\2016-2020\CFs aging\GXY\HCF 过表达和敲低\HCF P11 Down p53si\2019.11.16 p11p53si(p871582)\膜1\H-G 20191120_181350_Ch\H-G 20191120_181350_Ch+Marker.jpg"/>
          <p:cNvPicPr>
            <a:picLocks noChangeAspect="1" noChangeArrowheads="1"/>
          </p:cNvPicPr>
          <p:nvPr/>
        </p:nvPicPr>
        <p:blipFill>
          <a:blip r:embed="rId4" cstate="print"/>
          <a:srcRect l="41678" t="44622" r="8577" b="36954"/>
          <a:stretch>
            <a:fillRect/>
          </a:stretch>
        </p:blipFill>
        <p:spPr bwMode="auto">
          <a:xfrm>
            <a:off x="1331640" y="2394512"/>
            <a:ext cx="2160240" cy="720080"/>
          </a:xfrm>
          <a:prstGeom prst="rect">
            <a:avLst/>
          </a:prstGeom>
          <a:noFill/>
        </p:spPr>
      </p:pic>
      <p:pic>
        <p:nvPicPr>
          <p:cNvPr id="2054" name="Picture 6" descr="E:\论文\试验数据\2016-2020\CFs aging\GXY\HCF 过表达和敲低\HCF P11 Down p53si\2019.11.22 p11p53si(p871582 p863383)\膜1\3-COL1 20191122_204231_Ch\3-COL1 20191122_204231_Ch+Marker.jpg"/>
          <p:cNvPicPr>
            <a:picLocks noChangeAspect="1" noChangeArrowheads="1"/>
          </p:cNvPicPr>
          <p:nvPr/>
        </p:nvPicPr>
        <p:blipFill>
          <a:blip r:embed="rId5" cstate="print"/>
          <a:srcRect l="44217" t="36147" r="4196" b="38060"/>
          <a:stretch>
            <a:fillRect/>
          </a:stretch>
        </p:blipFill>
        <p:spPr bwMode="auto">
          <a:xfrm>
            <a:off x="5580112" y="764704"/>
            <a:ext cx="1944216" cy="792088"/>
          </a:xfrm>
          <a:prstGeom prst="rect">
            <a:avLst/>
          </a:prstGeom>
          <a:noFill/>
        </p:spPr>
      </p:pic>
      <p:pic>
        <p:nvPicPr>
          <p:cNvPr id="2055" name="Picture 7" descr="E:\论文\试验数据\2016-2020\CFs aging\GXY\HCF 过表达和敲低\HCF P11 Down p53si\2019.11.22 p11p53si(p871582 p863383)\膜1\3-G 20191122_182644_Ch\3-G 20191122_182644_Ch+Marker.jpg"/>
          <p:cNvPicPr>
            <a:picLocks noChangeAspect="1" noChangeArrowheads="1"/>
          </p:cNvPicPr>
          <p:nvPr/>
        </p:nvPicPr>
        <p:blipFill>
          <a:blip r:embed="rId6" cstate="print"/>
          <a:srcRect l="43367" t="45429" r="7846" b="37989"/>
          <a:stretch>
            <a:fillRect/>
          </a:stretch>
        </p:blipFill>
        <p:spPr bwMode="auto">
          <a:xfrm>
            <a:off x="5580112" y="2241704"/>
            <a:ext cx="1944216" cy="648072"/>
          </a:xfrm>
          <a:prstGeom prst="rect">
            <a:avLst/>
          </a:prstGeom>
          <a:noFill/>
        </p:spPr>
      </p:pic>
      <p:pic>
        <p:nvPicPr>
          <p:cNvPr id="2056" name="Picture 8" descr="E:\论文\试验数据\2016-2020\CFs aging\GXY\HCF 过表达和敲低\HCF P11 Down p53si\2019.11.22 p11p53si(p871582 p863383)\膜3\1-COL3 20191128_165416_Ch\1-COL3 20191128_165416_Ch+Marker.jpg"/>
          <p:cNvPicPr>
            <a:picLocks noChangeAspect="1" noChangeArrowheads="1"/>
          </p:cNvPicPr>
          <p:nvPr/>
        </p:nvPicPr>
        <p:blipFill>
          <a:blip r:embed="rId7" cstate="print"/>
          <a:srcRect l="49744" t="36848" b="41044"/>
          <a:stretch>
            <a:fillRect/>
          </a:stretch>
        </p:blipFill>
        <p:spPr bwMode="auto">
          <a:xfrm>
            <a:off x="5580113" y="1567256"/>
            <a:ext cx="1944216" cy="637608"/>
          </a:xfrm>
          <a:prstGeom prst="rect">
            <a:avLst/>
          </a:prstGeom>
          <a:noFill/>
        </p:spPr>
      </p:pic>
      <p:pic>
        <p:nvPicPr>
          <p:cNvPr id="2057" name="Picture 9" descr="E:\论文\试验数据\2016-2020\CFs aging\GXY\HCF 过表达和敲低\HCF P11 Down p53si\2020.5.28 p11~p12p53si(p846949 p874863)共3个板\p846949：板1\膜1（前3孔）\3-COL1 20200529_142701_Ch\3-COL1 20200529_142701_Ch+Marker.jpg"/>
          <p:cNvPicPr>
            <a:picLocks noChangeAspect="1" noChangeArrowheads="1"/>
          </p:cNvPicPr>
          <p:nvPr/>
        </p:nvPicPr>
        <p:blipFill>
          <a:blip r:embed="rId8" cstate="print"/>
          <a:srcRect t="34375" r="4196" b="41674"/>
          <a:stretch>
            <a:fillRect/>
          </a:stretch>
        </p:blipFill>
        <p:spPr bwMode="auto">
          <a:xfrm>
            <a:off x="1331640" y="3933056"/>
            <a:ext cx="4176464" cy="792088"/>
          </a:xfrm>
          <a:prstGeom prst="rect">
            <a:avLst/>
          </a:prstGeom>
          <a:noFill/>
        </p:spPr>
      </p:pic>
      <p:pic>
        <p:nvPicPr>
          <p:cNvPr id="2058" name="Picture 10" descr="E:\论文\试验数据\2016-2020\CFs aging\GXY\HCF 过表达和敲低\HCF P11 Down p53si\2020.5.28 p11~p12p53si(p846949 p874863)共3个板\p846949：板1\膜1（前3孔）\3-GAP 20200531_145232_Ch\GAPLYY 20200531_145232_Ch+Marker.jpg"/>
          <p:cNvPicPr>
            <a:picLocks noChangeAspect="1" noChangeArrowheads="1"/>
          </p:cNvPicPr>
          <p:nvPr/>
        </p:nvPicPr>
        <p:blipFill>
          <a:blip r:embed="rId9" cstate="print"/>
          <a:srcRect l="4906" t="37652" r="4089" b="40240"/>
          <a:stretch>
            <a:fillRect/>
          </a:stretch>
        </p:blipFill>
        <p:spPr bwMode="auto">
          <a:xfrm>
            <a:off x="1331640" y="5571656"/>
            <a:ext cx="4176464" cy="864096"/>
          </a:xfrm>
          <a:prstGeom prst="rect">
            <a:avLst/>
          </a:prstGeom>
          <a:noFill/>
        </p:spPr>
      </p:pic>
      <p:pic>
        <p:nvPicPr>
          <p:cNvPr id="2059" name="Picture 11" descr="E:\论文\试验数据\2016-2020\CFs aging\GXY\HCF 过表达和敲低\HCF P11 Down p53si\2020.5.28 p11~p12p53si(p846949 p874863)共3个板\p846949：板1\膜2（前3孔）\4-COL3 20200529_142428_Ch\4-COL3 20200529_142428_Ch+Marker.jpg"/>
          <p:cNvPicPr>
            <a:picLocks noChangeAspect="1" noChangeArrowheads="1"/>
          </p:cNvPicPr>
          <p:nvPr/>
        </p:nvPicPr>
        <p:blipFill>
          <a:blip r:embed="rId10" cstate="print"/>
          <a:srcRect l="5123" t="31973" r="4601" b="44076"/>
          <a:stretch>
            <a:fillRect/>
          </a:stretch>
        </p:blipFill>
        <p:spPr bwMode="auto">
          <a:xfrm>
            <a:off x="1322848" y="4744400"/>
            <a:ext cx="4185256" cy="792088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611560" y="980728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1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11560" y="1772816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3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7544" y="2636912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16016" y="908720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1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16016" y="1700808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3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644008" y="2420888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11560" y="4149080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1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1560" y="4941168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Col 3a1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67544" y="5805264"/>
            <a:ext cx="1008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APDH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07704" y="548680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     C        NC     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868144" y="575056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    NC  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638928" y="3743408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           C   NC 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53032" y="3743408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  NC 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774896" y="3743408"/>
            <a:ext cx="1728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  NC  p53siRNA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0" y="0"/>
            <a:ext cx="320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uman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atri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fibroblast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521288" y="4428320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70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331640" y="5157192"/>
            <a:ext cx="36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70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430024" y="611088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35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6660232" y="3356992"/>
            <a:ext cx="586508" cy="29741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1</TotalTime>
  <Words>168</Words>
  <Application>Microsoft Office PowerPoint</Application>
  <PresentationFormat>全屏显示(4:3)</PresentationFormat>
  <Paragraphs>118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raofang</dc:creator>
  <cp:lastModifiedBy>raofang</cp:lastModifiedBy>
  <cp:revision>39</cp:revision>
  <dcterms:created xsi:type="dcterms:W3CDTF">2020-12-14T02:07:35Z</dcterms:created>
  <dcterms:modified xsi:type="dcterms:W3CDTF">2020-12-16T02:23:08Z</dcterms:modified>
</cp:coreProperties>
</file>